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60" r:id="rId1"/>
  </p:sldMasterIdLst>
  <p:sldIdLst>
    <p:sldId id="275" r:id="rId2"/>
    <p:sldId id="272" r:id="rId3"/>
    <p:sldId id="274" r:id="rId4"/>
    <p:sldId id="277" r:id="rId5"/>
  </p:sldIdLst>
  <p:sldSz cx="6858000" cy="9906000" type="A4"/>
  <p:notesSz cx="6888163" cy="100203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48" d="100"/>
          <a:sy n="48" d="100"/>
        </p:scale>
        <p:origin x="226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477DA-4D92-41DD-9028-C22A6E869A03}" type="datetimeFigureOut">
              <a:rPr lang="zh-CN" altLang="en-US" smtClean="0"/>
              <a:t>2023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78DE1-54EF-4F5B-B388-66B05B32F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87570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477DA-4D92-41DD-9028-C22A6E869A03}" type="datetimeFigureOut">
              <a:rPr lang="zh-CN" altLang="en-US" smtClean="0"/>
              <a:t>2023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78DE1-54EF-4F5B-B388-66B05B32F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2721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477DA-4D92-41DD-9028-C22A6E869A03}" type="datetimeFigureOut">
              <a:rPr lang="zh-CN" altLang="en-US" smtClean="0"/>
              <a:t>2023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78DE1-54EF-4F5B-B388-66B05B32F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0110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477DA-4D92-41DD-9028-C22A6E869A03}" type="datetimeFigureOut">
              <a:rPr lang="zh-CN" altLang="en-US" smtClean="0"/>
              <a:t>2023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78DE1-54EF-4F5B-B388-66B05B32F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2945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477DA-4D92-41DD-9028-C22A6E869A03}" type="datetimeFigureOut">
              <a:rPr lang="zh-CN" altLang="en-US" smtClean="0"/>
              <a:t>2023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78DE1-54EF-4F5B-B388-66B05B32F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10465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477DA-4D92-41DD-9028-C22A6E869A03}" type="datetimeFigureOut">
              <a:rPr lang="zh-CN" altLang="en-US" smtClean="0"/>
              <a:t>2023/5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78DE1-54EF-4F5B-B388-66B05B32F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49529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477DA-4D92-41DD-9028-C22A6E869A03}" type="datetimeFigureOut">
              <a:rPr lang="zh-CN" altLang="en-US" smtClean="0"/>
              <a:t>2023/5/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78DE1-54EF-4F5B-B388-66B05B32F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97093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477DA-4D92-41DD-9028-C22A6E869A03}" type="datetimeFigureOut">
              <a:rPr lang="zh-CN" altLang="en-US" smtClean="0"/>
              <a:t>2023/5/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78DE1-54EF-4F5B-B388-66B05B32F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2435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477DA-4D92-41DD-9028-C22A6E869A03}" type="datetimeFigureOut">
              <a:rPr lang="zh-CN" altLang="en-US" smtClean="0"/>
              <a:t>2023/5/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78DE1-54EF-4F5B-B388-66B05B32F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60912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477DA-4D92-41DD-9028-C22A6E869A03}" type="datetimeFigureOut">
              <a:rPr lang="zh-CN" altLang="en-US" smtClean="0"/>
              <a:t>2023/5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78DE1-54EF-4F5B-B388-66B05B32F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7893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477DA-4D92-41DD-9028-C22A6E869A03}" type="datetimeFigureOut">
              <a:rPr lang="zh-CN" altLang="en-US" smtClean="0"/>
              <a:t>2023/5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78DE1-54EF-4F5B-B388-66B05B32F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46469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C477DA-4D92-41DD-9028-C22A6E869A03}" type="datetimeFigureOut">
              <a:rPr lang="zh-CN" altLang="en-US" smtClean="0"/>
              <a:t>2023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378DE1-54EF-4F5B-B388-66B05B32F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0045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BCFE3600-A3FD-4812-BE8B-61935B53E62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49690598"/>
              </p:ext>
            </p:extLst>
          </p:nvPr>
        </p:nvGraphicFramePr>
        <p:xfrm>
          <a:off x="733807" y="852367"/>
          <a:ext cx="4525720" cy="8379555"/>
        </p:xfrm>
        <a:graphic>
          <a:graphicData uri="http://schemas.openxmlformats.org/drawingml/2006/table">
            <a:tbl>
              <a:tblPr/>
              <a:tblGrid>
                <a:gridCol w="3388291">
                  <a:extLst>
                    <a:ext uri="{9D8B030D-6E8A-4147-A177-3AD203B41FA5}">
                      <a16:colId xmlns:a16="http://schemas.microsoft.com/office/drawing/2014/main" val="1151035436"/>
                    </a:ext>
                  </a:extLst>
                </a:gridCol>
                <a:gridCol w="470857">
                  <a:extLst>
                    <a:ext uri="{9D8B030D-6E8A-4147-A177-3AD203B41FA5}">
                      <a16:colId xmlns:a16="http://schemas.microsoft.com/office/drawing/2014/main" val="870821862"/>
                    </a:ext>
                  </a:extLst>
                </a:gridCol>
                <a:gridCol w="341832">
                  <a:extLst>
                    <a:ext uri="{9D8B030D-6E8A-4147-A177-3AD203B41FA5}">
                      <a16:colId xmlns:a16="http://schemas.microsoft.com/office/drawing/2014/main" val="3954134310"/>
                    </a:ext>
                  </a:extLst>
                </a:gridCol>
                <a:gridCol w="324740">
                  <a:extLst>
                    <a:ext uri="{9D8B030D-6E8A-4147-A177-3AD203B41FA5}">
                      <a16:colId xmlns:a16="http://schemas.microsoft.com/office/drawing/2014/main" val="2021441975"/>
                    </a:ext>
                  </a:extLst>
                </a:gridCol>
              </a:tblGrid>
              <a:tr h="11592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TU ID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verage reads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7872330"/>
                  </a:ext>
                </a:extLst>
              </a:tr>
              <a:tr h="1159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non-metastasis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etastasis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 value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4494835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coprophilus; OTU764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.51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4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74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1646570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unclassified_g__Bacteroides; OTU766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60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5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54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3013043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intestinalis_DSM_17393; OTU795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64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2.49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20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2578908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unclassified_g__Bacteroides; OTU801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2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31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2721943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unclassified_g__Bacteroides; OTU1148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2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31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9563499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metagenome_g__Bacteroides; OTU1151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9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31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5810096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ovatus; OTU2071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78.53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61.30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76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6000589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unclassified_g__Bacteroides; OTU2106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7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64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40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1698179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uniformis; OTU2249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1" i="0" u="none" strike="noStrike" dirty="0">
                          <a:solidFill>
                            <a:schemeClr val="accent1">
                              <a:lumMod val="75000"/>
                            </a:schemeClr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1.82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1" i="0" u="none" strike="noStrike" dirty="0">
                          <a:solidFill>
                            <a:schemeClr val="accent1">
                              <a:lumMod val="75000"/>
                            </a:schemeClr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27.62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1" i="0" u="none" strike="noStrike" dirty="0">
                          <a:solidFill>
                            <a:schemeClr val="accent1">
                              <a:lumMod val="75000"/>
                            </a:schemeClr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67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1718838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fragilis; OTU2272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1" i="0" u="none" strike="noStrike" dirty="0">
                          <a:solidFill>
                            <a:schemeClr val="accent1">
                              <a:lumMod val="75000"/>
                            </a:schemeClr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772.44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1" i="0" u="none" strike="noStrike" dirty="0">
                          <a:solidFill>
                            <a:schemeClr val="accent1">
                              <a:lumMod val="75000"/>
                            </a:schemeClr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377.32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1" i="0" u="none" strike="noStrike" dirty="0">
                          <a:solidFill>
                            <a:schemeClr val="accent1">
                              <a:lumMod val="75000"/>
                            </a:schemeClr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76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8329798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helcogenes_P_36-108; OTU2328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1.96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31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6129294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clarus; OTU2484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.84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60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582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3114742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cellulosilyticus; OTU2485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2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3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51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7624070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uncultured_bacterium_g__Bacteroides; OTU2647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6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31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4871006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sp._Marseille-P3166; OTU2852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2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3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51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7200332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uncultured_bacterium_g__Bacteroides; OTU2938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6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31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0493513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fragilis; OTU3067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1.91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0.45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875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3305286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unclassified_g__Bacteroides; OTU4146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2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9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70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1339773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unclassified_g__Bacteroides; OTU4321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84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49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578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9579151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eggerthii; OTU4334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1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8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24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0729172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ovatus_V975; OTU4337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51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5.49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26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6426262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pyogenes; OTU5613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.67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.64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17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3610231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caccae; OTU5672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0.78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26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9449493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plebeius; OTU5915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26.11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86.77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748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1661487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vulgatus; OTU5922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3.04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1.06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562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7255308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unclassified_g__Bacteroides; OTU5969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109.96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629.85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521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4712038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thetaiotaomicron; OTU5978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.09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.60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79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3174695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stercoris_ATCC_43183; OTU6652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04.62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87.36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645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263347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unclassified_g__Bacteroides; OTU7474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7.56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5.02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41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3427695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uncultured_bacterium_g__Bacteroides; OTU7481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9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31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936040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barnesiae; OTU7813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47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09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598099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fluxus; OTU7831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1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31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8724017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sp._Marseille-P3108; OTU7971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8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31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4902510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massiliensis; OTU8025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5.78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74.91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87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9684551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coprocola_DSM_17136; OTU8033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2.67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0.19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530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6843946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graminisolvens; OTU8053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2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31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3200563"/>
                  </a:ext>
                </a:extLst>
              </a:tr>
              <a:tr h="1159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_Bacteria;k__norank_d__Bacteria;p__Bacteroidota;c__Bacteroidia;o__Bacteroidales;f__Bacteroidaceae;g__Bacteroides;s__Bacteroides_nordii; OTU8105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4.82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1.62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500 </a:t>
                      </a:r>
                    </a:p>
                  </a:txBody>
                  <a:tcPr marL="4104" marR="4104" marT="410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5651101"/>
                  </a:ext>
                </a:extLst>
              </a:tr>
            </a:tbl>
          </a:graphicData>
        </a:graphic>
      </p:graphicFrame>
      <p:sp>
        <p:nvSpPr>
          <p:cNvPr id="6" name="文本框 5">
            <a:extLst>
              <a:ext uri="{FF2B5EF4-FFF2-40B4-BE49-F238E27FC236}">
                <a16:creationId xmlns:a16="http://schemas.microsoft.com/office/drawing/2014/main" id="{2AADBBE1-DA77-41BE-AFA2-A364E6A2BC0E}"/>
              </a:ext>
            </a:extLst>
          </p:cNvPr>
          <p:cNvSpPr txBox="1"/>
          <p:nvPr/>
        </p:nvSpPr>
        <p:spPr>
          <a:xfrm>
            <a:off x="-95773" y="483035"/>
            <a:ext cx="68640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Supplementary table 1. The OTUs that belong to Bacteroides genus </a:t>
            </a:r>
            <a:endParaRPr lang="zh-CN" altLang="en-US" b="1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4427832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746C70B3-67AF-4920-DDAF-1D7B402AA9F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9282"/>
          <a:stretch/>
        </p:blipFill>
        <p:spPr>
          <a:xfrm>
            <a:off x="3406971" y="1998259"/>
            <a:ext cx="2785600" cy="2852458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11A1A337-AF2F-ED98-AD2C-5D6C559DE35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46298" y="2136055"/>
            <a:ext cx="1553904" cy="2634538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0041FA6C-4BD1-1E90-2683-2C92B3C7D7B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5915" y="2251209"/>
            <a:ext cx="1515335" cy="250814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DA800420-10D9-4942-9D97-1212B529612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5350" y="3997349"/>
            <a:ext cx="1163389" cy="7239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2D380EEE-675D-4B85-90FC-A9571A516DD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61250" y="3952630"/>
            <a:ext cx="1163389" cy="723900"/>
          </a:xfrm>
          <a:prstGeom prst="rect">
            <a:avLst/>
          </a:prstGeom>
        </p:spPr>
      </p:pic>
      <p:grpSp>
        <p:nvGrpSpPr>
          <p:cNvPr id="7" name="组合 6">
            <a:extLst>
              <a:ext uri="{FF2B5EF4-FFF2-40B4-BE49-F238E27FC236}">
                <a16:creationId xmlns:a16="http://schemas.microsoft.com/office/drawing/2014/main" id="{00F6E903-DDFF-4AA7-99D0-C59913339179}"/>
              </a:ext>
            </a:extLst>
          </p:cNvPr>
          <p:cNvGrpSpPr/>
          <p:nvPr/>
        </p:nvGrpSpPr>
        <p:grpSpPr>
          <a:xfrm>
            <a:off x="559395" y="3841798"/>
            <a:ext cx="750189" cy="1111202"/>
            <a:chOff x="1445443" y="2910928"/>
            <a:chExt cx="750189" cy="1111202"/>
          </a:xfrm>
        </p:grpSpPr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E8543159-AF7C-43A5-8D1F-0E38AE18F8D7}"/>
                </a:ext>
              </a:extLst>
            </p:cNvPr>
            <p:cNvSpPr txBox="1"/>
            <p:nvPr/>
          </p:nvSpPr>
          <p:spPr>
            <a:xfrm rot="18813752">
              <a:off x="997564" y="3358807"/>
              <a:ext cx="1111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non-metastatic CRC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48CBA627-78E3-43C9-BBD9-40475E246986}"/>
                </a:ext>
              </a:extLst>
            </p:cNvPr>
            <p:cNvSpPr txBox="1"/>
            <p:nvPr/>
          </p:nvSpPr>
          <p:spPr>
            <a:xfrm rot="18813752">
              <a:off x="1635702" y="3330085"/>
              <a:ext cx="9044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metastatic CRC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97279C35-C5F1-44DF-BE91-050AAF6D2B76}"/>
              </a:ext>
            </a:extLst>
          </p:cNvPr>
          <p:cNvGrpSpPr/>
          <p:nvPr/>
        </p:nvGrpSpPr>
        <p:grpSpPr>
          <a:xfrm>
            <a:off x="2009131" y="3803698"/>
            <a:ext cx="774681" cy="1111202"/>
            <a:chOff x="1445443" y="2910928"/>
            <a:chExt cx="774681" cy="1111202"/>
          </a:xfrm>
        </p:grpSpPr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89D6B8C4-1577-43B6-A3C7-DA465BA4345A}"/>
                </a:ext>
              </a:extLst>
            </p:cNvPr>
            <p:cNvSpPr txBox="1"/>
            <p:nvPr/>
          </p:nvSpPr>
          <p:spPr>
            <a:xfrm rot="18813752">
              <a:off x="997564" y="3358807"/>
              <a:ext cx="1111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non-metastatic CRC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7802B69E-0E01-46EF-BA17-4EBEC7E38430}"/>
                </a:ext>
              </a:extLst>
            </p:cNvPr>
            <p:cNvSpPr txBox="1"/>
            <p:nvPr/>
          </p:nvSpPr>
          <p:spPr>
            <a:xfrm rot="18813752">
              <a:off x="1660194" y="3321986"/>
              <a:ext cx="9044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metastatic CRC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6" name="图片 15">
            <a:extLst>
              <a:ext uri="{FF2B5EF4-FFF2-40B4-BE49-F238E27FC236}">
                <a16:creationId xmlns:a16="http://schemas.microsoft.com/office/drawing/2014/main" id="{20FBC451-21D7-4BE4-A631-31221DD9736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524665" y="1559037"/>
            <a:ext cx="286202" cy="417573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381581A2-F14D-4460-8D81-B0457EA1D425}"/>
              </a:ext>
            </a:extLst>
          </p:cNvPr>
          <p:cNvSpPr txBox="1"/>
          <p:nvPr/>
        </p:nvSpPr>
        <p:spPr>
          <a:xfrm rot="44432">
            <a:off x="5775277" y="1565808"/>
            <a:ext cx="1111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on-metastatic CR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F549110D-C7D7-413B-91CA-DE76790865F7}"/>
              </a:ext>
            </a:extLst>
          </p:cNvPr>
          <p:cNvSpPr txBox="1"/>
          <p:nvPr/>
        </p:nvSpPr>
        <p:spPr>
          <a:xfrm rot="44432">
            <a:off x="5775286" y="1775930"/>
            <a:ext cx="9044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etastatic CR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DCF1E37E-4191-4CE5-B308-B83959B43734}"/>
              </a:ext>
            </a:extLst>
          </p:cNvPr>
          <p:cNvSpPr txBox="1"/>
          <p:nvPr/>
        </p:nvSpPr>
        <p:spPr>
          <a:xfrm>
            <a:off x="80097" y="531563"/>
            <a:ext cx="62562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Supplementary Figure 1. </a:t>
            </a:r>
            <a:endParaRPr lang="zh-CN" altLang="en-US" b="1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CFD7E8DD-732C-4C00-A108-F49C21F8C8EA}"/>
              </a:ext>
            </a:extLst>
          </p:cNvPr>
          <p:cNvSpPr txBox="1"/>
          <p:nvPr/>
        </p:nvSpPr>
        <p:spPr>
          <a:xfrm>
            <a:off x="84378" y="191517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6E5B4114-1D1B-4AB5-A43A-48A3CE15074B}"/>
              </a:ext>
            </a:extLst>
          </p:cNvPr>
          <p:cNvSpPr txBox="1"/>
          <p:nvPr/>
        </p:nvSpPr>
        <p:spPr>
          <a:xfrm>
            <a:off x="1646298" y="188584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F6C19554-BDFC-462B-86F0-6C5D8014C73B}"/>
              </a:ext>
            </a:extLst>
          </p:cNvPr>
          <p:cNvSpPr txBox="1"/>
          <p:nvPr/>
        </p:nvSpPr>
        <p:spPr>
          <a:xfrm>
            <a:off x="3252121" y="180403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84A1C001-A796-4A32-BDFF-F22763200FCF}"/>
              </a:ext>
            </a:extLst>
          </p:cNvPr>
          <p:cNvSpPr txBox="1"/>
          <p:nvPr/>
        </p:nvSpPr>
        <p:spPr>
          <a:xfrm>
            <a:off x="128521" y="5292118"/>
            <a:ext cx="660095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1. 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the α-/β-diversity of bacteria in metastatic and non-metastatic CRC groups.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Chao index and (B) Shannon index indicate the α-diversity of microbial communities. (C) non-metric multidimensional scaling analysis (NMDS) indicates the β-diversity of the microbial communities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24016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63F3A88C-8FF1-404C-A94C-11186713C070}"/>
              </a:ext>
            </a:extLst>
          </p:cNvPr>
          <p:cNvSpPr txBox="1"/>
          <p:nvPr/>
        </p:nvSpPr>
        <p:spPr>
          <a:xfrm>
            <a:off x="78525" y="349987"/>
            <a:ext cx="670094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Supplementary Figure 2. </a:t>
            </a:r>
            <a:endParaRPr lang="zh-CN" altLang="en-US" b="1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339EBF7C-52F8-4AC8-97C8-918427621B50}"/>
              </a:ext>
            </a:extLst>
          </p:cNvPr>
          <p:cNvSpPr txBox="1"/>
          <p:nvPr/>
        </p:nvSpPr>
        <p:spPr>
          <a:xfrm>
            <a:off x="257042" y="7204023"/>
            <a:ext cx="660095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2. The differentially abundant species between metastatic and non-metastatic CRC </a:t>
            </a:r>
            <a:r>
              <a:rPr lang="en-US" altLang="zh-CN" sz="1000" b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alysed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by linear discriminant analysis effect size (</a:t>
            </a:r>
            <a:r>
              <a:rPr lang="en-US" altLang="zh-CN" sz="1000" b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EfSe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.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 most differentially abundant taxa of mucosal-associated microbiome between in metastatic and non-metastatic CRC groups. LDA Score: linear discriminant analysis score.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12BDD634-3C90-4342-87FE-01F960584032}"/>
              </a:ext>
            </a:extLst>
          </p:cNvPr>
          <p:cNvGrpSpPr/>
          <p:nvPr/>
        </p:nvGrpSpPr>
        <p:grpSpPr>
          <a:xfrm>
            <a:off x="645569" y="1357346"/>
            <a:ext cx="4612188" cy="5328701"/>
            <a:chOff x="645569" y="1357346"/>
            <a:chExt cx="4612188" cy="5328701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 rotWithShape="1">
            <a:blip r:embed="rId2"/>
            <a:srcRect b="45464"/>
            <a:stretch/>
          </p:blipFill>
          <p:spPr>
            <a:xfrm>
              <a:off x="645569" y="1357346"/>
              <a:ext cx="4612188" cy="2963549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0D4D2A5E-9E3B-4EAB-B98E-45D51FD710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56476"/>
            <a:stretch/>
          </p:blipFill>
          <p:spPr>
            <a:xfrm>
              <a:off x="645569" y="4320895"/>
              <a:ext cx="4612188" cy="23651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1232547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AD9E1C72-C61F-4314-ACC7-3E413272D334}"/>
              </a:ext>
            </a:extLst>
          </p:cNvPr>
          <p:cNvSpPr txBox="1"/>
          <p:nvPr/>
        </p:nvSpPr>
        <p:spPr>
          <a:xfrm>
            <a:off x="2979734" y="1688054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63.6%</a:t>
            </a:r>
            <a:endParaRPr lang="zh-CN" altLang="en-US" sz="1000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3449A0B0-383A-4EC4-A4E4-F80E40D202B4}"/>
              </a:ext>
            </a:extLst>
          </p:cNvPr>
          <p:cNvSpPr txBox="1"/>
          <p:nvPr/>
        </p:nvSpPr>
        <p:spPr>
          <a:xfrm>
            <a:off x="3525013" y="1356375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85.4%</a:t>
            </a:r>
            <a:endParaRPr lang="zh-CN" altLang="en-US" sz="1000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6A7AE480-EF2D-4551-A7DA-01329D97953B}"/>
              </a:ext>
            </a:extLst>
          </p:cNvPr>
          <p:cNvSpPr txBox="1"/>
          <p:nvPr/>
        </p:nvSpPr>
        <p:spPr>
          <a:xfrm>
            <a:off x="184522" y="4368392"/>
            <a:ext cx="660095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3. </a:t>
            </a:r>
            <a:r>
              <a:rPr lang="en-US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acteroides fragilis 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oxin</a:t>
            </a:r>
            <a:r>
              <a:rPr lang="en-US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ft</a:t>
            </a:r>
            <a:r>
              <a:rPr lang="en-US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 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e test.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63.6% of nonmetastatic CRC tissues were </a:t>
            </a:r>
            <a:r>
              <a:rPr lang="en-US" altLang="zh-CN" sz="1000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ft</a:t>
            </a:r>
            <a:r>
              <a:rPr lang="en-US" altLang="zh-CN" sz="1000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e positive compared with 85.4% of metastatic CRC tissues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9515DEE5-9316-4B56-B9CC-1E6AD4B43B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91816" y="706876"/>
            <a:ext cx="2228850" cy="340995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63F3A88C-8FF1-404C-A94C-11186713C070}"/>
              </a:ext>
            </a:extLst>
          </p:cNvPr>
          <p:cNvSpPr txBox="1"/>
          <p:nvPr/>
        </p:nvSpPr>
        <p:spPr>
          <a:xfrm>
            <a:off x="78525" y="349987"/>
            <a:ext cx="670094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Supplementary Figure </a:t>
            </a:r>
            <a:r>
              <a:rPr lang="en-US" altLang="zh-CN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3. </a:t>
            </a:r>
            <a:endParaRPr lang="zh-CN" altLang="en-US" b="1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2578786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83</TotalTime>
  <Words>1100</Words>
  <Application>Microsoft Office PowerPoint</Application>
  <PresentationFormat>A4 纸张(210x297 毫米)</PresentationFormat>
  <Paragraphs>172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2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Windows 用户</cp:lastModifiedBy>
  <cp:revision>83</cp:revision>
  <cp:lastPrinted>2022-07-26T08:33:57Z</cp:lastPrinted>
  <dcterms:created xsi:type="dcterms:W3CDTF">2022-07-14T00:59:26Z</dcterms:created>
  <dcterms:modified xsi:type="dcterms:W3CDTF">2023-05-09T15:03:14Z</dcterms:modified>
</cp:coreProperties>
</file>